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73" r:id="rId3"/>
    <p:sldId id="280" r:id="rId4"/>
  </p:sldIdLst>
  <p:sldSz cx="6264275" cy="7562850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2">
          <p15:clr>
            <a:srgbClr val="A4A3A4"/>
          </p15:clr>
        </p15:guide>
        <p15:guide id="2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CC00FF"/>
    <a:srgbClr val="3399FF"/>
    <a:srgbClr val="33CC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851"/>
    <p:restoredTop sz="98441" autoAdjust="0"/>
  </p:normalViewPr>
  <p:slideViewPr>
    <p:cSldViewPr snapToGrid="0">
      <p:cViewPr varScale="1">
        <p:scale>
          <a:sx n="75" d="100"/>
          <a:sy n="75" d="100"/>
        </p:scale>
        <p:origin x="474" y="66"/>
      </p:cViewPr>
      <p:guideLst>
        <p:guide orient="horz" pos="2382"/>
        <p:guide pos="19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349386"/>
            <a:ext cx="5324634" cy="162111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285615"/>
            <a:ext cx="4384993" cy="193272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11DBDCD-A11D-4234-A35E-45BF14E934B0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C0A1225-245F-47D8-9F17-ED17397CAB6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7C8B63D-56D0-482C-81C6-8D5F33193A09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3F76D73-9CAD-437D-8A3A-A392CDF72E80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41599" y="302865"/>
            <a:ext cx="1409462" cy="645293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3214" y="302865"/>
            <a:ext cx="4123981" cy="645293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1525423-8D16-44A8-93FC-3CBA0EF02083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9CFB3B1-516B-43CA-9083-FE65BA34CF89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0E1D8A6-E6CB-49C6-AC87-7650FAC81627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63B13D9-F089-4668-8A20-037F2029E319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4" y="4859832"/>
            <a:ext cx="5324634" cy="150206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4" y="3205459"/>
            <a:ext cx="5324634" cy="165437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707905E-5854-468F-8FC5-B8C624251820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005981E-A58C-4384-85BF-54F3AE229882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3214" y="1764666"/>
            <a:ext cx="2766721" cy="49911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4340" y="1764666"/>
            <a:ext cx="2766721" cy="49911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2118CFF-546F-46AA-8574-6084FAB066C9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CC70252-7532-4119-98C8-211F940A8319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692889"/>
            <a:ext cx="2767809" cy="7055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398404"/>
            <a:ext cx="2767809" cy="435739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5" y="1692889"/>
            <a:ext cx="2768897" cy="7055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5" y="2398404"/>
            <a:ext cx="2768897" cy="435739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D8DB8B3-EBF8-4C68-B029-6CB7BB96C001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FED5468-C907-47F1-B03A-1747CF12C1F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6E3C4E7-A6CB-4B9E-A659-C9D4AB54E3A0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FCE31B7-07AF-48A4-8499-95AF3675560A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9FEACA2-7B2A-41D9-B222-56485481A4E7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78AC57-BF28-4EE8-B0FB-C65F3C6DE24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01113"/>
            <a:ext cx="2060903" cy="128148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7" y="301114"/>
            <a:ext cx="3501904" cy="64546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582597"/>
            <a:ext cx="2060903" cy="51732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813132A-8F87-4FF8-88A4-E89DBED7D2AB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CD1BC3F-ABB6-4EC6-B92B-770C4780AE6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293995"/>
            <a:ext cx="3758565" cy="6249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675755"/>
            <a:ext cx="3758565" cy="45377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5918981"/>
            <a:ext cx="3758565" cy="88758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20DF81A-B677-4288-BCA3-74DBBF93F3E0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71EB5F0-37AB-4610-8078-877EC677885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02865"/>
            <a:ext cx="5637848" cy="1260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764666"/>
            <a:ext cx="5637848" cy="49911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009642"/>
            <a:ext cx="1461664" cy="402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671BBBE3-AB91-4664-98D2-1683A3682FAC}" type="datetimeFigureOut">
              <a:rPr lang="en-US" smtClean="0"/>
              <a:pPr>
                <a:defRPr/>
              </a:pPr>
              <a:t>8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009642"/>
            <a:ext cx="1983687" cy="402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009642"/>
            <a:ext cx="1461664" cy="402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CD4DC7D-4ECB-4EBB-9192-B4388578B1C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image" Target="../media/image14.emf"/><Relationship Id="rId18" Type="http://schemas.openxmlformats.org/officeDocument/2006/relationships/image" Target="../media/image19.emf"/><Relationship Id="rId26" Type="http://schemas.openxmlformats.org/officeDocument/2006/relationships/image" Target="../media/image27.emf"/><Relationship Id="rId3" Type="http://schemas.openxmlformats.org/officeDocument/2006/relationships/image" Target="../media/image4.emf"/><Relationship Id="rId21" Type="http://schemas.openxmlformats.org/officeDocument/2006/relationships/image" Target="../media/image22.emf"/><Relationship Id="rId7" Type="http://schemas.openxmlformats.org/officeDocument/2006/relationships/image" Target="../media/image8.emf"/><Relationship Id="rId12" Type="http://schemas.openxmlformats.org/officeDocument/2006/relationships/image" Target="../media/image13.emf"/><Relationship Id="rId17" Type="http://schemas.openxmlformats.org/officeDocument/2006/relationships/image" Target="../media/image18.emf"/><Relationship Id="rId25" Type="http://schemas.openxmlformats.org/officeDocument/2006/relationships/image" Target="../media/image26.emf"/><Relationship Id="rId2" Type="http://schemas.openxmlformats.org/officeDocument/2006/relationships/image" Target="../media/image3.emf"/><Relationship Id="rId16" Type="http://schemas.openxmlformats.org/officeDocument/2006/relationships/image" Target="../media/image17.emf"/><Relationship Id="rId20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24" Type="http://schemas.openxmlformats.org/officeDocument/2006/relationships/image" Target="../media/image25.emf"/><Relationship Id="rId5" Type="http://schemas.openxmlformats.org/officeDocument/2006/relationships/image" Target="../media/image6.emf"/><Relationship Id="rId15" Type="http://schemas.openxmlformats.org/officeDocument/2006/relationships/image" Target="../media/image16.emf"/><Relationship Id="rId23" Type="http://schemas.openxmlformats.org/officeDocument/2006/relationships/image" Target="../media/image24.emf"/><Relationship Id="rId28" Type="http://schemas.openxmlformats.org/officeDocument/2006/relationships/image" Target="../media/image29.emf"/><Relationship Id="rId10" Type="http://schemas.openxmlformats.org/officeDocument/2006/relationships/image" Target="../media/image11.emf"/><Relationship Id="rId19" Type="http://schemas.openxmlformats.org/officeDocument/2006/relationships/image" Target="../media/image20.emf"/><Relationship Id="rId4" Type="http://schemas.openxmlformats.org/officeDocument/2006/relationships/image" Target="../media/image5.emf"/><Relationship Id="rId9" Type="http://schemas.openxmlformats.org/officeDocument/2006/relationships/image" Target="../media/image10.emf"/><Relationship Id="rId14" Type="http://schemas.openxmlformats.org/officeDocument/2006/relationships/image" Target="../media/image15.emf"/><Relationship Id="rId22" Type="http://schemas.openxmlformats.org/officeDocument/2006/relationships/image" Target="../media/image23.emf"/><Relationship Id="rId27" Type="http://schemas.openxmlformats.org/officeDocument/2006/relationships/image" Target="../media/image2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f"/><Relationship Id="rId3" Type="http://schemas.openxmlformats.org/officeDocument/2006/relationships/image" Target="../media/image31.jpeg"/><Relationship Id="rId7" Type="http://schemas.openxmlformats.org/officeDocument/2006/relationships/image" Target="../media/image35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74517" y="6951012"/>
            <a:ext cx="2093843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03003" y="460627"/>
            <a:ext cx="5854897" cy="1742828"/>
            <a:chOff x="177603" y="2949827"/>
            <a:chExt cx="5854897" cy="1742828"/>
          </a:xfrm>
        </p:grpSpPr>
        <p:cxnSp>
          <p:nvCxnSpPr>
            <p:cNvPr id="4" name="Straight Arrow Connector 3"/>
            <p:cNvCxnSpPr/>
            <p:nvPr/>
          </p:nvCxnSpPr>
          <p:spPr>
            <a:xfrm flipV="1">
              <a:off x="2771577" y="3543300"/>
              <a:ext cx="663773" cy="119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2673273" y="3132204"/>
              <a:ext cx="873259" cy="230822"/>
            </a:xfrm>
            <a:prstGeom prst="rect">
              <a:avLst/>
            </a:prstGeom>
            <a:noFill/>
            <a:effectLst/>
          </p:spPr>
          <p:txBody>
            <a:bodyPr wrap="none" lIns="91432" tIns="45715" rIns="91432" bIns="45715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ransposition</a:t>
              </a:r>
            </a:p>
          </p:txBody>
        </p:sp>
        <p:pic>
          <p:nvPicPr>
            <p:cNvPr id="6" name="Picture 5" descr="Ip1.jpg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70400" y="4247663"/>
              <a:ext cx="609203" cy="444987"/>
            </a:xfrm>
            <a:prstGeom prst="rect">
              <a:avLst/>
            </a:prstGeom>
          </p:spPr>
        </p:pic>
        <p:pic>
          <p:nvPicPr>
            <p:cNvPr id="7" name="Picture 6" descr="Ip1 Empty.jpg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9663" y="4248150"/>
              <a:ext cx="610237" cy="444505"/>
            </a:xfrm>
            <a:prstGeom prst="rect">
              <a:avLst/>
            </a:prstGeom>
          </p:spPr>
        </p:pic>
        <p:sp>
          <p:nvSpPr>
            <p:cNvPr id="8" name="Oval 7"/>
            <p:cNvSpPr/>
            <p:nvPr/>
          </p:nvSpPr>
          <p:spPr>
            <a:xfrm>
              <a:off x="4347064" y="3504426"/>
              <a:ext cx="1400443" cy="346421"/>
            </a:xfrm>
            <a:prstGeom prst="ellipse">
              <a:avLst/>
            </a:prstGeom>
            <a:noFill/>
            <a:ln w="12700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Oval 8"/>
            <p:cNvSpPr/>
            <p:nvPr/>
          </p:nvSpPr>
          <p:spPr>
            <a:xfrm>
              <a:off x="1019174" y="3499013"/>
              <a:ext cx="1400443" cy="346421"/>
            </a:xfrm>
            <a:prstGeom prst="ellipse">
              <a:avLst/>
            </a:prstGeom>
            <a:noFill/>
            <a:ln w="12700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1583693" y="3498957"/>
              <a:ext cx="2089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Left Bracket 10"/>
            <p:cNvSpPr/>
            <p:nvPr/>
          </p:nvSpPr>
          <p:spPr>
            <a:xfrm>
              <a:off x="1589340" y="3455655"/>
              <a:ext cx="40657" cy="86605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110853" tIns="55426" rIns="110853" bIns="55426" spcCol="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ight Bracket 11"/>
            <p:cNvSpPr/>
            <p:nvPr/>
          </p:nvSpPr>
          <p:spPr>
            <a:xfrm>
              <a:off x="1753102" y="3455655"/>
              <a:ext cx="40657" cy="8660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110853" tIns="55426" rIns="110853" bIns="55426" spcCol="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 flipV="1">
              <a:off x="1984490" y="3731709"/>
              <a:ext cx="136" cy="101386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>
            <a:xfrm flipH="1">
              <a:off x="1871863" y="3737121"/>
              <a:ext cx="107116" cy="56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Oval 14"/>
            <p:cNvSpPr/>
            <p:nvPr/>
          </p:nvSpPr>
          <p:spPr>
            <a:xfrm>
              <a:off x="646300" y="3385288"/>
              <a:ext cx="293641" cy="254403"/>
            </a:xfrm>
            <a:prstGeom prst="ellipse">
              <a:avLst/>
            </a:prstGeom>
            <a:noFill/>
            <a:ln w="12700">
              <a:solidFill>
                <a:srgbClr val="00009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110853" tIns="55426" rIns="110853" bIns="55426" spcCol="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708416" y="3369050"/>
              <a:ext cx="180702" cy="64954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110853" tIns="55426" rIns="110853" bIns="55426" spcCol="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 flipH="1" flipV="1">
              <a:off x="606771" y="3401527"/>
              <a:ext cx="62117" cy="54129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flipV="1">
              <a:off x="612418" y="3336573"/>
              <a:ext cx="79057" cy="64954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764885" y="3163362"/>
              <a:ext cx="536457" cy="265823"/>
            </a:xfrm>
            <a:prstGeom prst="rect">
              <a:avLst/>
            </a:prstGeom>
            <a:noFill/>
            <a:effectLst/>
          </p:spPr>
          <p:txBody>
            <a:bodyPr wrap="none" lIns="110853" tIns="55426" rIns="110853" bIns="55426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’ase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03174" y="3129082"/>
              <a:ext cx="347303" cy="250434"/>
            </a:xfrm>
            <a:prstGeom prst="rect">
              <a:avLst/>
            </a:prstGeom>
            <a:noFill/>
            <a:effectLst/>
          </p:spPr>
          <p:txBody>
            <a:bodyPr wrap="none" lIns="110853" tIns="55426" rIns="110853" bIns="55426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1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75246" y="3618039"/>
              <a:ext cx="714390" cy="250434"/>
            </a:xfrm>
            <a:prstGeom prst="rect">
              <a:avLst/>
            </a:prstGeom>
            <a:noFill/>
            <a:effectLst/>
          </p:spPr>
          <p:txBody>
            <a:bodyPr wrap="none" lIns="110853" tIns="55426" rIns="110853" bIns="55426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 = 1 or 5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888628" y="3493545"/>
              <a:ext cx="347303" cy="250434"/>
            </a:xfrm>
            <a:prstGeom prst="rect">
              <a:avLst/>
            </a:prstGeom>
            <a:noFill/>
            <a:effectLst/>
          </p:spPr>
          <p:txBody>
            <a:bodyPr wrap="none" lIns="110853" tIns="55426" rIns="110853" bIns="55426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1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290051" y="3222904"/>
              <a:ext cx="818586" cy="265823"/>
            </a:xfrm>
            <a:prstGeom prst="rect">
              <a:avLst/>
            </a:prstGeom>
            <a:noFill/>
            <a:effectLst/>
          </p:spPr>
          <p:txBody>
            <a:bodyPr wrap="none" lIns="110853" tIns="55426" rIns="110853" bIns="55426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’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an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Oval 23"/>
            <p:cNvSpPr/>
            <p:nvPr/>
          </p:nvSpPr>
          <p:spPr>
            <a:xfrm>
              <a:off x="177603" y="2949827"/>
              <a:ext cx="2512891" cy="1187843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110853" tIns="55426" rIns="110853" bIns="55426" spcCol="0"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Straight Connector 24"/>
            <p:cNvCxnSpPr/>
            <p:nvPr/>
          </p:nvCxnSpPr>
          <p:spPr>
            <a:xfrm>
              <a:off x="4925699" y="3501487"/>
              <a:ext cx="2089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Left Bracket 25"/>
            <p:cNvSpPr/>
            <p:nvPr/>
          </p:nvSpPr>
          <p:spPr>
            <a:xfrm>
              <a:off x="4931345" y="3458185"/>
              <a:ext cx="40657" cy="86605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ight Bracket 26"/>
            <p:cNvSpPr/>
            <p:nvPr/>
          </p:nvSpPr>
          <p:spPr>
            <a:xfrm>
              <a:off x="5095107" y="3458185"/>
              <a:ext cx="40657" cy="8660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Oval 27"/>
            <p:cNvSpPr/>
            <p:nvPr/>
          </p:nvSpPr>
          <p:spPr>
            <a:xfrm>
              <a:off x="3988305" y="3387818"/>
              <a:ext cx="293641" cy="254403"/>
            </a:xfrm>
            <a:prstGeom prst="ellipse">
              <a:avLst/>
            </a:prstGeom>
            <a:noFill/>
            <a:ln w="12700">
              <a:solidFill>
                <a:srgbClr val="00009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050422" y="3371579"/>
              <a:ext cx="180702" cy="64954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H="1" flipV="1">
              <a:off x="3948777" y="3404056"/>
              <a:ext cx="62117" cy="54129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flipV="1">
              <a:off x="3954424" y="3339103"/>
              <a:ext cx="79057" cy="64954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4106891" y="3165892"/>
              <a:ext cx="464899" cy="230045"/>
            </a:xfrm>
            <a:prstGeom prst="rect">
              <a:avLst/>
            </a:prstGeom>
            <a:noFill/>
            <a:effectLst/>
          </p:spPr>
          <p:txBody>
            <a:bodyPr wrap="none" lIns="75420" tIns="37710" rIns="75420" bIns="3771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’ase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754898" y="3137024"/>
              <a:ext cx="275745" cy="214656"/>
            </a:xfrm>
            <a:prstGeom prst="rect">
              <a:avLst/>
            </a:prstGeom>
            <a:noFill/>
            <a:effectLst/>
          </p:spPr>
          <p:txBody>
            <a:bodyPr wrap="none" lIns="75420" tIns="37710" rIns="75420" bIns="37710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1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717252" y="3620569"/>
              <a:ext cx="694128" cy="230045"/>
            </a:xfrm>
            <a:prstGeom prst="rect">
              <a:avLst/>
            </a:prstGeom>
            <a:noFill/>
            <a:effectLst/>
          </p:spPr>
          <p:txBody>
            <a:bodyPr wrap="none" lIns="75420" tIns="37710" rIns="75420" bIns="3771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 = 1 or 5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656600" y="3874972"/>
              <a:ext cx="718174" cy="230045"/>
            </a:xfrm>
            <a:prstGeom prst="rect">
              <a:avLst/>
            </a:prstGeom>
            <a:noFill/>
            <a:effectLst/>
          </p:spPr>
          <p:txBody>
            <a:bodyPr wrap="none" lIns="75420" tIns="37710" rIns="75420" bIns="37710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acZ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an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endParaRPr lang="en-US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Oval 35"/>
            <p:cNvSpPr/>
            <p:nvPr/>
          </p:nvSpPr>
          <p:spPr>
            <a:xfrm>
              <a:off x="3519609" y="2952169"/>
              <a:ext cx="2512891" cy="11880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Connector 36"/>
            <p:cNvCxnSpPr/>
            <p:nvPr/>
          </p:nvCxnSpPr>
          <p:spPr>
            <a:xfrm flipV="1">
              <a:off x="5419672" y="3720884"/>
              <a:ext cx="136" cy="101386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 flipH="1">
              <a:off x="5307045" y="3726296"/>
              <a:ext cx="107116" cy="56"/>
            </a:xfrm>
            <a:prstGeom prst="straightConnector1">
              <a:avLst/>
            </a:prstGeom>
            <a:ln w="9525" cmpd="sng">
              <a:solidFill>
                <a:schemeClr val="tx1"/>
              </a:solidFill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5352045" y="3547673"/>
              <a:ext cx="347303" cy="250434"/>
            </a:xfrm>
            <a:prstGeom prst="rect">
              <a:avLst/>
            </a:prstGeom>
            <a:noFill/>
            <a:effectLst/>
          </p:spPr>
          <p:txBody>
            <a:bodyPr wrap="none" lIns="110853" tIns="55426" rIns="110853" bIns="55426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1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5078166" y="3847908"/>
              <a:ext cx="2089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Left Bracket 40"/>
            <p:cNvSpPr/>
            <p:nvPr/>
          </p:nvSpPr>
          <p:spPr>
            <a:xfrm>
              <a:off x="5083812" y="3804605"/>
              <a:ext cx="40657" cy="86605"/>
            </a:xfrm>
            <a:prstGeom prst="lef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ight Bracket 41"/>
            <p:cNvSpPr/>
            <p:nvPr/>
          </p:nvSpPr>
          <p:spPr>
            <a:xfrm>
              <a:off x="5247574" y="3804605"/>
              <a:ext cx="40657" cy="8660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75420" tIns="37710" rIns="75420" bIns="37710"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Rectangle 43"/>
          <p:cNvSpPr/>
          <p:nvPr/>
        </p:nvSpPr>
        <p:spPr>
          <a:xfrm>
            <a:off x="1" y="2548185"/>
            <a:ext cx="6264274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F1. Representation of the modified </a:t>
            </a:r>
            <a:r>
              <a:rPr lang="en-US" sz="1200" b="1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papillation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assay.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he Hsmar1 (RC5096), which encodes a promoter-less </a:t>
            </a:r>
            <a:r>
              <a:rPr lang="en-GB" sz="1200" i="1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lacZ</a:t>
            </a: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gene and a kanamycin resistance marker, has been integrated at a transcriptionally silent locus in a lac- E. coli strain. In absence of transposase, the </a:t>
            </a:r>
            <a:r>
              <a:rPr lang="en-GB" sz="1200" i="1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lacZ</a:t>
            </a: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gene is not expressed therefore the strain produces white colonies on X-gal reporter plates. When the transposase is supplied in trans from a vector, if a transposon integrates into the ORF of a transcribed gene, a </a:t>
            </a:r>
            <a:r>
              <a:rPr lang="en-GB" sz="1200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lacZ</a:t>
            </a: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fusion protein will be produced. The cell’s descendants will expressed </a:t>
            </a:r>
            <a:r>
              <a:rPr lang="en-GB" sz="1200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LacZ</a:t>
            </a: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therefore will appear as blue papillae on X-gal reporter plates. Black arrow, promoter; open brackets, transposon ends; empty rectangle, transposase gene. 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or the mating-out assay, a chloramphenicol resistant derivative of the conjugative plasmid pOX38 is introduced into the reporter strain. Transposition of the reporter into the plasmid is detected by selecting </a:t>
            </a:r>
            <a:r>
              <a:rPr lang="en-US" sz="1200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ransconjugants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after mating with a recipient strain on chloramphenicol and kanamycin.  </a:t>
            </a:r>
          </a:p>
        </p:txBody>
      </p:sp>
    </p:spTree>
    <p:extLst>
      <p:ext uri="{BB962C8B-B14F-4D97-AF65-F5344CB8AC3E}">
        <p14:creationId xmlns:p14="http://schemas.microsoft.com/office/powerpoint/2010/main" val="625380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67"/>
          <p:cNvSpPr txBox="1"/>
          <p:nvPr/>
        </p:nvSpPr>
        <p:spPr>
          <a:xfrm>
            <a:off x="3974517" y="6951012"/>
            <a:ext cx="2093843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grpSp>
        <p:nvGrpSpPr>
          <p:cNvPr id="69" name="Group 68"/>
          <p:cNvGrpSpPr/>
          <p:nvPr/>
        </p:nvGrpSpPr>
        <p:grpSpPr>
          <a:xfrm>
            <a:off x="158826" y="251383"/>
            <a:ext cx="5707037" cy="4589071"/>
            <a:chOff x="100897" y="2560151"/>
            <a:chExt cx="5212955" cy="4191776"/>
          </a:xfrm>
        </p:grpSpPr>
        <p:pic>
          <p:nvPicPr>
            <p:cNvPr id="70" name="Picture 69" descr="Ip0.emf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82897" y="3130804"/>
              <a:ext cx="587099" cy="597516"/>
            </a:xfrm>
            <a:prstGeom prst="rect">
              <a:avLst/>
            </a:prstGeom>
          </p:spPr>
        </p:pic>
        <p:pic>
          <p:nvPicPr>
            <p:cNvPr id="71" name="Picture 70" descr="Bp4-.emf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65103" y="3133194"/>
              <a:ext cx="584751" cy="595126"/>
            </a:xfrm>
            <a:prstGeom prst="rect">
              <a:avLst/>
            </a:prstGeom>
          </p:spPr>
        </p:pic>
        <p:pic>
          <p:nvPicPr>
            <p:cNvPr id="72" name="Picture 71" descr="Bp3-.em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2418" y="3133194"/>
              <a:ext cx="584751" cy="595126"/>
            </a:xfrm>
            <a:prstGeom prst="rect">
              <a:avLst/>
            </a:prstGeom>
          </p:spPr>
        </p:pic>
        <p:pic>
          <p:nvPicPr>
            <p:cNvPr id="73" name="Picture 72" descr="Bp5-.emf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17286" y="3133194"/>
              <a:ext cx="594438" cy="592886"/>
            </a:xfrm>
            <a:prstGeom prst="rect">
              <a:avLst/>
            </a:prstGeom>
          </p:spPr>
        </p:pic>
        <p:pic>
          <p:nvPicPr>
            <p:cNvPr id="74" name="Picture 73" descr="Bp2-.emf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75030" y="3133194"/>
              <a:ext cx="584653" cy="597407"/>
            </a:xfrm>
            <a:prstGeom prst="rect">
              <a:avLst/>
            </a:prstGeom>
          </p:spPr>
        </p:pic>
        <p:pic>
          <p:nvPicPr>
            <p:cNvPr id="75" name="Picture 74" descr="Bp1+.emf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62129" y="3133194"/>
              <a:ext cx="584653" cy="595026"/>
            </a:xfrm>
            <a:prstGeom prst="rect">
              <a:avLst/>
            </a:prstGeom>
          </p:spPr>
        </p:pic>
        <p:pic>
          <p:nvPicPr>
            <p:cNvPr id="76" name="Picture 75" descr="Bp1N.emf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387403" y="3133195"/>
              <a:ext cx="584751" cy="595126"/>
            </a:xfrm>
            <a:prstGeom prst="rect">
              <a:avLst/>
            </a:prstGeom>
          </p:spPr>
        </p:pic>
        <p:pic>
          <p:nvPicPr>
            <p:cNvPr id="77" name="Picture 76" descr="Bp1-.emf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849228" y="3133194"/>
              <a:ext cx="587099" cy="597516"/>
            </a:xfrm>
            <a:prstGeom prst="rect">
              <a:avLst/>
            </a:prstGeom>
          </p:spPr>
        </p:pic>
        <p:sp>
          <p:nvSpPr>
            <p:cNvPr id="78" name="TextBox 77"/>
            <p:cNvSpPr txBox="1"/>
            <p:nvPr/>
          </p:nvSpPr>
          <p:spPr>
            <a:xfrm>
              <a:off x="529672" y="2845550"/>
              <a:ext cx="35609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0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058061" y="2855469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4-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635375" y="2845550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3-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212689" y="2855469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5-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770433" y="2845550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2-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347747" y="2845550"/>
              <a:ext cx="48641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1+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944632" y="2845550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1-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463236" y="2855469"/>
              <a:ext cx="50398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1N</a:t>
              </a:r>
            </a:p>
          </p:txBody>
        </p:sp>
        <p:pic>
          <p:nvPicPr>
            <p:cNvPr id="86" name="Picture 85" descr="Bp6-.emf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8004" y="3932210"/>
              <a:ext cx="591992" cy="602496"/>
            </a:xfrm>
            <a:prstGeom prst="rect">
              <a:avLst/>
            </a:prstGeom>
          </p:spPr>
        </p:pic>
        <p:pic>
          <p:nvPicPr>
            <p:cNvPr id="87" name="Picture 86" descr="Bp3+.emf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65103" y="3932209"/>
              <a:ext cx="594496" cy="605045"/>
            </a:xfrm>
            <a:prstGeom prst="rect">
              <a:avLst/>
            </a:prstGeom>
          </p:spPr>
        </p:pic>
        <p:pic>
          <p:nvPicPr>
            <p:cNvPr id="88" name="Picture 87" descr="Ip2-.emf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2418" y="3932209"/>
              <a:ext cx="594496" cy="605045"/>
            </a:xfrm>
            <a:prstGeom prst="rect">
              <a:avLst/>
            </a:prstGeom>
          </p:spPr>
        </p:pic>
        <p:pic>
          <p:nvPicPr>
            <p:cNvPr id="89" name="Picture 88" descr="Ip3-.emf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09948" y="3932210"/>
              <a:ext cx="591992" cy="602496"/>
            </a:xfrm>
            <a:prstGeom prst="rect">
              <a:avLst/>
            </a:prstGeom>
          </p:spPr>
        </p:pic>
        <p:pic>
          <p:nvPicPr>
            <p:cNvPr id="90" name="Picture 89" descr="Ip1+.emf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72583" y="3932209"/>
              <a:ext cx="594496" cy="605045"/>
            </a:xfrm>
            <a:prstGeom prst="rect">
              <a:avLst/>
            </a:prstGeom>
          </p:spPr>
        </p:pic>
        <p:pic>
          <p:nvPicPr>
            <p:cNvPr id="91" name="Picture 90" descr="Bp2+.emf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62129" y="3932209"/>
              <a:ext cx="594496" cy="605045"/>
            </a:xfrm>
            <a:prstGeom prst="rect">
              <a:avLst/>
            </a:prstGeom>
          </p:spPr>
        </p:pic>
        <p:pic>
          <p:nvPicPr>
            <p:cNvPr id="92" name="Picture 91" descr="Ip5-.emf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841889" y="3932209"/>
              <a:ext cx="591992" cy="602496"/>
            </a:xfrm>
            <a:prstGeom prst="rect">
              <a:avLst/>
            </a:prstGeom>
          </p:spPr>
        </p:pic>
        <p:pic>
          <p:nvPicPr>
            <p:cNvPr id="93" name="Picture 92" descr="Ip4-.emf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24096" y="3932209"/>
              <a:ext cx="594496" cy="605045"/>
            </a:xfrm>
            <a:prstGeom prst="rect">
              <a:avLst/>
            </a:prstGeom>
          </p:spPr>
        </p:pic>
        <p:sp>
          <p:nvSpPr>
            <p:cNvPr id="94" name="TextBox 93"/>
            <p:cNvSpPr txBox="1"/>
            <p:nvPr/>
          </p:nvSpPr>
          <p:spPr>
            <a:xfrm>
              <a:off x="480747" y="3693765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6-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058061" y="3703683"/>
              <a:ext cx="48641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3+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674515" y="3693765"/>
              <a:ext cx="401491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2-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242044" y="3703683"/>
              <a:ext cx="401491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3-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780218" y="3693765"/>
              <a:ext cx="435167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1+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347747" y="3693765"/>
              <a:ext cx="48641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2+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973987" y="3693765"/>
              <a:ext cx="401491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5-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551301" y="3693765"/>
              <a:ext cx="401491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4-</a:t>
              </a:r>
            </a:p>
          </p:txBody>
        </p:sp>
        <p:pic>
          <p:nvPicPr>
            <p:cNvPr id="102" name="Picture 101" descr="Ip1-.emf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8004" y="4752242"/>
              <a:ext cx="594496" cy="605045"/>
            </a:xfrm>
            <a:prstGeom prst="rect">
              <a:avLst/>
            </a:prstGeom>
          </p:spPr>
        </p:pic>
        <p:pic>
          <p:nvPicPr>
            <p:cNvPr id="103" name="Picture 102" descr="Bp4+.emf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65103" y="4752242"/>
              <a:ext cx="594497" cy="605045"/>
            </a:xfrm>
            <a:prstGeom prst="rect">
              <a:avLst/>
            </a:prstGeom>
          </p:spPr>
        </p:pic>
        <p:pic>
          <p:nvPicPr>
            <p:cNvPr id="104" name="Picture 103" descr="Ip1N.emf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2418" y="4752242"/>
              <a:ext cx="594496" cy="605045"/>
            </a:xfrm>
            <a:prstGeom prst="rect">
              <a:avLst/>
            </a:prstGeom>
          </p:spPr>
        </p:pic>
        <p:pic>
          <p:nvPicPr>
            <p:cNvPr id="105" name="Picture 104" descr="Ip6-.emf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09947" y="4752243"/>
              <a:ext cx="591992" cy="602496"/>
            </a:xfrm>
            <a:prstGeom prst="rect">
              <a:avLst/>
            </a:prstGeom>
          </p:spPr>
        </p:pic>
        <p:pic>
          <p:nvPicPr>
            <p:cNvPr id="106" name="Picture 105" descr="Bp5+.emf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14170" y="4752242"/>
              <a:ext cx="584751" cy="595126"/>
            </a:xfrm>
            <a:prstGeom prst="rect">
              <a:avLst/>
            </a:prstGeom>
          </p:spPr>
        </p:pic>
        <p:pic>
          <p:nvPicPr>
            <p:cNvPr id="107" name="Picture 106" descr="Bp6+.emf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64575" y="4752242"/>
              <a:ext cx="594496" cy="605045"/>
            </a:xfrm>
            <a:prstGeom prst="rect">
              <a:avLst/>
            </a:prstGeom>
          </p:spPr>
        </p:pic>
        <p:pic>
          <p:nvPicPr>
            <p:cNvPr id="108" name="Picture 107" descr="Ip2+.emf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849229" y="4752242"/>
              <a:ext cx="584751" cy="595126"/>
            </a:xfrm>
            <a:prstGeom prst="rect">
              <a:avLst/>
            </a:prstGeom>
          </p:spPr>
        </p:pic>
        <p:pic>
          <p:nvPicPr>
            <p:cNvPr id="109" name="Picture 108" descr="Ip3+.emf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26542" y="4752242"/>
              <a:ext cx="594438" cy="604985"/>
            </a:xfrm>
            <a:prstGeom prst="rect">
              <a:avLst/>
            </a:prstGeom>
          </p:spPr>
        </p:pic>
        <p:sp>
          <p:nvSpPr>
            <p:cNvPr id="110" name="TextBox 109"/>
            <p:cNvSpPr txBox="1"/>
            <p:nvPr/>
          </p:nvSpPr>
          <p:spPr>
            <a:xfrm>
              <a:off x="510102" y="4504273"/>
              <a:ext cx="401491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1-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058061" y="4504273"/>
              <a:ext cx="48641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4+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1645160" y="4504273"/>
              <a:ext cx="452739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1N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242044" y="4504273"/>
              <a:ext cx="401491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6-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799788" y="4504273"/>
              <a:ext cx="48641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5+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357532" y="4504273"/>
              <a:ext cx="486416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p6+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954417" y="4504273"/>
              <a:ext cx="435167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2+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531731" y="4504273"/>
              <a:ext cx="435167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3+</a:t>
              </a:r>
            </a:p>
          </p:txBody>
        </p:sp>
        <p:pic>
          <p:nvPicPr>
            <p:cNvPr id="118" name="Picture 117" descr="Ip4+.emf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8004" y="5600851"/>
              <a:ext cx="594496" cy="605045"/>
            </a:xfrm>
            <a:prstGeom prst="rect">
              <a:avLst/>
            </a:prstGeom>
          </p:spPr>
        </p:pic>
        <p:pic>
          <p:nvPicPr>
            <p:cNvPr id="119" name="Picture 118" descr="Ip5+.emf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65103" y="5600851"/>
              <a:ext cx="594496" cy="605045"/>
            </a:xfrm>
            <a:prstGeom prst="rect">
              <a:avLst/>
            </a:prstGeom>
          </p:spPr>
        </p:pic>
        <p:pic>
          <p:nvPicPr>
            <p:cNvPr id="120" name="Picture 119" descr="Ip6+.emf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52203" y="5600851"/>
              <a:ext cx="594496" cy="605045"/>
            </a:xfrm>
            <a:prstGeom prst="rect">
              <a:avLst/>
            </a:prstGeom>
          </p:spPr>
        </p:pic>
        <p:sp>
          <p:nvSpPr>
            <p:cNvPr id="121" name="TextBox 120"/>
            <p:cNvSpPr txBox="1"/>
            <p:nvPr/>
          </p:nvSpPr>
          <p:spPr>
            <a:xfrm>
              <a:off x="490532" y="5342963"/>
              <a:ext cx="435167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4+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077631" y="5342963"/>
              <a:ext cx="435167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5+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664730" y="5342963"/>
              <a:ext cx="435167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6+</a:t>
              </a:r>
            </a:p>
          </p:txBody>
        </p:sp>
        <p:cxnSp>
          <p:nvCxnSpPr>
            <p:cNvPr id="124" name="Straight Arrow Connector 123"/>
            <p:cNvCxnSpPr/>
            <p:nvPr/>
          </p:nvCxnSpPr>
          <p:spPr>
            <a:xfrm flipV="1">
              <a:off x="363327" y="2986274"/>
              <a:ext cx="0" cy="321962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>
              <a:off x="391458" y="6343370"/>
              <a:ext cx="47548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25"/>
            <p:cNvSpPr txBox="1"/>
            <p:nvPr/>
          </p:nvSpPr>
          <p:spPr>
            <a:xfrm>
              <a:off x="2299587" y="6505938"/>
              <a:ext cx="534735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 rot="16200000">
              <a:off x="-328267" y="4512083"/>
              <a:ext cx="1104318" cy="24598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mber of cells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286526" y="2560151"/>
              <a:ext cx="5027326" cy="2536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204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sorter assay for amount of EGFP produced from the respective plasmids 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2989171" y="6396611"/>
              <a:ext cx="359028" cy="23825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95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119380" y="6387537"/>
              <a:ext cx="359028" cy="23825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95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850951" y="6388992"/>
              <a:ext cx="359028" cy="23825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95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730960" y="6382828"/>
              <a:ext cx="359028" cy="238259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95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133" name="Straight Connector 132"/>
            <p:cNvCxnSpPr/>
            <p:nvPr/>
          </p:nvCxnSpPr>
          <p:spPr>
            <a:xfrm>
              <a:off x="91313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>
              <a:off x="203786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>
              <a:off x="317608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>
              <a:off x="4302129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>
              <a:off x="552883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/>
            <p:nvPr/>
          </p:nvCxnSpPr>
          <p:spPr>
            <a:xfrm>
              <a:off x="649015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71960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790285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842210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/>
            <p:cNvCxnSpPr/>
            <p:nvPr/>
          </p:nvCxnSpPr>
          <p:spPr>
            <a:xfrm>
              <a:off x="168629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/>
            <p:cNvCxnSpPr/>
            <p:nvPr/>
          </p:nvCxnSpPr>
          <p:spPr>
            <a:xfrm>
              <a:off x="1782424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/>
            <p:nvPr/>
          </p:nvCxnSpPr>
          <p:spPr>
            <a:xfrm>
              <a:off x="185301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/>
            <p:cNvCxnSpPr/>
            <p:nvPr/>
          </p:nvCxnSpPr>
          <p:spPr>
            <a:xfrm>
              <a:off x="1923694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>
              <a:off x="1975619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2816583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/>
            <p:cNvCxnSpPr/>
            <p:nvPr/>
          </p:nvCxnSpPr>
          <p:spPr>
            <a:xfrm>
              <a:off x="2912715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/>
            <p:cNvCxnSpPr/>
            <p:nvPr/>
          </p:nvCxnSpPr>
          <p:spPr>
            <a:xfrm>
              <a:off x="298330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/>
            <p:cNvCxnSpPr/>
            <p:nvPr/>
          </p:nvCxnSpPr>
          <p:spPr>
            <a:xfrm>
              <a:off x="3053985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>
              <a:off x="3105910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/>
            <p:cNvCxnSpPr/>
            <p:nvPr/>
          </p:nvCxnSpPr>
          <p:spPr>
            <a:xfrm>
              <a:off x="395167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/>
            <p:cNvCxnSpPr/>
            <p:nvPr/>
          </p:nvCxnSpPr>
          <p:spPr>
            <a:xfrm>
              <a:off x="4047803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4118390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4189073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4240998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>
              <a:off x="463368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/>
            <p:cNvCxnSpPr/>
            <p:nvPr/>
          </p:nvCxnSpPr>
          <p:spPr>
            <a:xfrm>
              <a:off x="484826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Connector 158"/>
            <p:cNvCxnSpPr/>
            <p:nvPr/>
          </p:nvCxnSpPr>
          <p:spPr>
            <a:xfrm>
              <a:off x="4985180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/>
            <p:nvPr/>
          </p:nvCxnSpPr>
          <p:spPr>
            <a:xfrm>
              <a:off x="3499509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>
            <a:xfrm>
              <a:off x="3714088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/>
            <p:nvPr/>
          </p:nvCxnSpPr>
          <p:spPr>
            <a:xfrm>
              <a:off x="3851007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Connector 162"/>
            <p:cNvCxnSpPr/>
            <p:nvPr/>
          </p:nvCxnSpPr>
          <p:spPr>
            <a:xfrm>
              <a:off x="236970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258428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>
              <a:off x="2721200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1241122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1455701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1592620" y="6346921"/>
              <a:ext cx="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 flipH="1">
              <a:off x="422481" y="6136459"/>
              <a:ext cx="1222679" cy="180703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>
            <a:xfrm>
              <a:off x="2109947" y="6137874"/>
              <a:ext cx="2892219" cy="159875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1" name="Rectangle 170"/>
          <p:cNvSpPr/>
          <p:nvPr/>
        </p:nvSpPr>
        <p:spPr>
          <a:xfrm>
            <a:off x="9807" y="5422838"/>
            <a:ext cx="610352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F2. FACS profiles of the vectors used in this study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Example of FACS profile for each vector expressing the </a:t>
            </a:r>
            <a:r>
              <a:rPr lang="en-US" sz="1200" i="1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eGFP</a:t>
            </a:r>
            <a:r>
              <a:rPr lang="en-US" sz="1200" i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gene. Ip0 is the negative control (empty vector). </a:t>
            </a:r>
            <a:endParaRPr lang="en-US" sz="12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1875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69040" y="7119539"/>
            <a:ext cx="2093843" cy="307777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defTabSz="500543" fontAlgn="base">
              <a:spcBef>
                <a:spcPct val="0"/>
              </a:spcBef>
              <a:spcAft>
                <a:spcPct val="0"/>
              </a:spcAft>
            </a:pP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0110" y="1201687"/>
            <a:ext cx="316112" cy="32823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defTabSz="500543" fontAlgn="base">
              <a:spcBef>
                <a:spcPct val="0"/>
              </a:spcBef>
              <a:spcAft>
                <a:spcPct val="0"/>
              </a:spcAft>
            </a:pPr>
            <a:r>
              <a:rPr lang="en-US" sz="153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50110" y="82395"/>
            <a:ext cx="5329609" cy="1020197"/>
            <a:chOff x="50110" y="82395"/>
            <a:chExt cx="5329609" cy="1020197"/>
          </a:xfrm>
        </p:grpSpPr>
        <p:pic>
          <p:nvPicPr>
            <p:cNvPr id="6" name="Picture 5" descr="Ip3 0 2.jpg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70143" y="533201"/>
              <a:ext cx="609601" cy="457200"/>
            </a:xfrm>
            <a:prstGeom prst="rect">
              <a:avLst/>
            </a:prstGeom>
          </p:spPr>
        </p:pic>
        <p:pic>
          <p:nvPicPr>
            <p:cNvPr id="7" name="Picture 6" descr="Ip3 0_01 6.jpg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53362" y="533201"/>
              <a:ext cx="609600" cy="457200"/>
            </a:xfrm>
            <a:prstGeom prst="rect">
              <a:avLst/>
            </a:prstGeom>
          </p:spPr>
        </p:pic>
        <p:pic>
          <p:nvPicPr>
            <p:cNvPr id="8" name="Picture 7" descr="Ip3 0_1 1.jpg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35494" y="533200"/>
              <a:ext cx="609600" cy="457200"/>
            </a:xfrm>
            <a:prstGeom prst="rect">
              <a:avLst/>
            </a:prstGeom>
          </p:spPr>
        </p:pic>
        <p:pic>
          <p:nvPicPr>
            <p:cNvPr id="9" name="Picture 8" descr="Ip3 0_05 1.jpg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04788" y="533200"/>
              <a:ext cx="609600" cy="457200"/>
            </a:xfrm>
            <a:prstGeom prst="rect">
              <a:avLst/>
            </a:prstGeom>
          </p:spPr>
        </p:pic>
        <p:pic>
          <p:nvPicPr>
            <p:cNvPr id="10" name="Picture 9" descr="Ip3 0_5 1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86923" y="533201"/>
              <a:ext cx="609600" cy="457200"/>
            </a:xfrm>
            <a:prstGeom prst="rect">
              <a:avLst/>
            </a:prstGeom>
          </p:spPr>
        </p:pic>
        <p:pic>
          <p:nvPicPr>
            <p:cNvPr id="11" name="Picture 10" descr="Ip3 1 1.jpg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770118" y="533201"/>
              <a:ext cx="609601" cy="4572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390427" y="479344"/>
              <a:ext cx="906017" cy="623248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3++ </a:t>
              </a:r>
            </a:p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Five copy,</a:t>
              </a:r>
            </a:p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BS++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0110" y="82395"/>
              <a:ext cx="316112" cy="32823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533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87446" y="239729"/>
              <a:ext cx="397865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079806" y="239729"/>
              <a:ext cx="603049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778014" y="239729"/>
              <a:ext cx="603049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458205" y="239729"/>
              <a:ext cx="521297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125346" y="239729"/>
              <a:ext cx="521297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%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855271" y="239729"/>
              <a:ext cx="397865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15156" y="263304"/>
              <a:ext cx="700833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ctose</a:t>
              </a: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189706" y="1514759"/>
            <a:ext cx="2545788" cy="3041153"/>
            <a:chOff x="189706" y="1514759"/>
            <a:chExt cx="2545788" cy="3041153"/>
          </a:xfrm>
        </p:grpSpPr>
        <p:pic>
          <p:nvPicPr>
            <p:cNvPr id="37" name="Picture 36" descr="DiffLactoseConcentration.tiff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4047" b="29012"/>
            <a:stretch/>
          </p:blipFill>
          <p:spPr>
            <a:xfrm>
              <a:off x="546644" y="1514759"/>
              <a:ext cx="2188850" cy="2369201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1249811" y="1537457"/>
              <a:ext cx="1120820" cy="269304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3++ Hsmar1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-646014" y="2497602"/>
              <a:ext cx="2100788" cy="429348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an number of papillae </a:t>
              </a:r>
            </a:p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r colony (± SEM)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8171651">
              <a:off x="672239" y="3900154"/>
              <a:ext cx="388248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8171651">
              <a:off x="859845" y="3986390"/>
              <a:ext cx="583813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rot="18171651">
              <a:off x="1179566" y="3986390"/>
              <a:ext cx="583813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rot="18171651">
              <a:off x="1564934" y="3951749"/>
              <a:ext cx="505267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 rot="18171651">
              <a:off x="1892389" y="3951749"/>
              <a:ext cx="505267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%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8171651">
              <a:off x="2293433" y="3900154"/>
              <a:ext cx="388248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394520" y="4295071"/>
              <a:ext cx="678391" cy="26084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 defTabSz="500543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95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ctose</a:t>
              </a:r>
            </a:p>
          </p:txBody>
        </p:sp>
      </p:grpSp>
      <p:sp>
        <p:nvSpPr>
          <p:cNvPr id="47" name="Rectangle 46"/>
          <p:cNvSpPr/>
          <p:nvPr/>
        </p:nvSpPr>
        <p:spPr>
          <a:xfrm>
            <a:off x="-35654" y="4898342"/>
            <a:ext cx="629992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F3. Effect of lactose on the modified </a:t>
            </a:r>
            <a:r>
              <a:rPr lang="en-US" sz="1200" b="1" dirty="0" err="1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papillation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assay.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/ 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colony of the Ip3++ untagged Hsmar1 vector on different concentration of lactose. </a:t>
            </a:r>
          </a:p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B/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Quantification of the number of papillae per colony. Average </a:t>
            </a: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± 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tandard deviation of the mean of six representative colonies.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3689015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Custom 3">
      <a:dk1>
        <a:sysClr val="windowText" lastClr="000000"/>
      </a:dk1>
      <a:lt1>
        <a:sysClr val="window" lastClr="FFFFFF"/>
      </a:lt1>
      <a:dk2>
        <a:srgbClr val="04100E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chemeClr val="tx1"/>
          </a:solidFill>
        </a:ln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  <a:effectLst/>
      </a:spPr>
      <a:bodyPr wrap="none" rtlCol="0">
        <a:spAutoFit/>
      </a:bodyPr>
      <a:lstStyle>
        <a:defPPr>
          <a:defRPr sz="1100" dirty="0" smtClean="0">
            <a:latin typeface="Arial"/>
            <a:cs typeface="Arial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1732</TotalTime>
  <Words>395</Words>
  <Application>Microsoft Office PowerPoint</Application>
  <PresentationFormat>Custom</PresentationFormat>
  <Paragraphs>7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MS Mincho</vt:lpstr>
      <vt:lpstr>Arial</vt:lpstr>
      <vt:lpstr>Calibri</vt:lpstr>
      <vt:lpstr>Cambria</vt:lpstr>
      <vt:lpstr>Times New Roman</vt:lpstr>
      <vt:lpstr>Default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ald Chalmers</dc:creator>
  <cp:lastModifiedBy>Michael</cp:lastModifiedBy>
  <cp:revision>70</cp:revision>
  <dcterms:created xsi:type="dcterms:W3CDTF">2019-06-21T19:20:37Z</dcterms:created>
  <dcterms:modified xsi:type="dcterms:W3CDTF">2019-08-06T14:09:56Z</dcterms:modified>
</cp:coreProperties>
</file>